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66" r:id="rId5"/>
    <p:sldId id="270" r:id="rId6"/>
    <p:sldId id="267" r:id="rId7"/>
    <p:sldId id="260" r:id="rId8"/>
    <p:sldId id="261" r:id="rId9"/>
    <p:sldId id="262" r:id="rId10"/>
  </p:sldIdLst>
  <p:sldSz cx="12192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1" autoAdjust="0"/>
    <p:restoredTop sz="82313" autoAdjust="0"/>
  </p:normalViewPr>
  <p:slideViewPr>
    <p:cSldViewPr snapToGrid="0">
      <p:cViewPr varScale="1">
        <p:scale>
          <a:sx n="44" d="100"/>
          <a:sy n="44" d="100"/>
        </p:scale>
        <p:origin x="244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FA68AB-BB43-42EB-AC2F-A485024CB1A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57400" y="1143000"/>
            <a:ext cx="2743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CE4CE8-6396-4B79-8B31-EF8A199DA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452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>
              <a:spcAft>
                <a:spcPts val="1200"/>
              </a:spcAft>
              <a:buNone/>
            </a:pPr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: No activation or recruitment of Gα</a:t>
            </a:r>
            <a:r>
              <a:rPr lang="en-US" sz="18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t ACKR3 despite its ability to form Gα</a:t>
            </a:r>
            <a:r>
              <a:rPr lang="en-US" sz="18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β-</a:t>
            </a:r>
            <a:r>
              <a:rPr lang="en-US" sz="18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stin</a:t>
            </a:r>
            <a:r>
              <a:rPr lang="en-US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mplexes.</a:t>
            </a:r>
          </a:p>
          <a:p>
            <a:pPr marL="0" marR="0" algn="just"/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nonical signaling in HEK293T cells overexpressing ACKR3 following treatment with CXCL11, Bam22, WW36, and WW38 by the following assays: (A) β-arrestin2 recruitment to ACKR3 assessed by BRET between ACKR3 tagged wit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nill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luciferase II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lucI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nd β-arrestin2-mKO. (B) ACKR3 Internalization assessed by loss of BRET betwee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yrpalm-mVenu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ACKR3-RlucII upon endocytosis. (C) G protein activation by ACKR3 assessed by TRUPATH BRET2 assay. (D)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cruitment to ACKR3 assessed by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ano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cruitment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-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o ACKR3-SmBiT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=3 for all ligands and represent independently run plate assays. Graphs depict the mean values at each dosage of ligand ± SEM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9275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buNone/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2: Size exclusion chromatography traces 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nodispersed peaks were observed for purification of (A) Non-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ipidated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1, (B) N-terminally tagged Protein C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arrestin-1 393X, and (C) N-terminally tagged Protein C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arrestin-2 392X. Purity of the fractions indicated with arrows was confirmed by Coomassie gel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5986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>
              <a:spcAft>
                <a:spcPts val="1200"/>
              </a:spcAft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3. No increase of Gα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β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stin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mplex formation after receptor independent modulation of Gα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>
              <a:lnSpc>
                <a:spcPct val="107000"/>
              </a:lnSpc>
              <a:spcAft>
                <a:spcPts val="800"/>
              </a:spcAft>
              <a:buFont typeface="+mj-lt"/>
              <a:buNone/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(A) Illustration of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noBRE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ssay. Briefly, HEK293T cells were transiently  transfected with V2R, Gα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-Nluc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noluciferase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, and β-arrestin2-mKO. Cells were treated either vehicle or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then analyzed in a plate reader for production of BRET upon G protein activation by either vasopressin or 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or 30 reads. Afterwards, 500nM AVP was added to cells to activate V2R and cells were analyzed again for changes in BRET signaling in comparison to vehicle control. (B)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noBRE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netics comparing Gα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:β-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rrestin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ells treated with varying concentrations of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r AVP (500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M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(C) Net BRET ratio between reads 10-15 from the kinetic read in panel B displayed as a bar graph. ****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&lt;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0.0001 by two-way ANOVA with Bonferroni post hoc comparing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ment versus AVP. (D)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noBRE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dose response curve comparing the net BRET ratio following AVP treatment (500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M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in cells that hat no pre-treatment of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r 60µM of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ed prior. (E)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anoBRE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ssay comparing formation of Gα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:β-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rrestin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fter V2R activation with AVP when AGS3, TPR, or GPR is overexpressed.  </a:t>
            </a:r>
            <a:r>
              <a:rPr lang="en-US" sz="1800" i="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s; P&gt;0.05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y two-way ANOVA with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onferron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ost hoc test comparing AlF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treatment to non-treated groups (D) and cells overexpressed with AGS3WT to TPR or GPR mutant overexpression controls (E).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=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 independently run plate replicates. Graphs depict mean values ± SEM.</a:t>
            </a:r>
            <a:endParaRPr lang="en-US" sz="18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just"/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926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>
              <a:spcAft>
                <a:spcPts val="1200"/>
              </a:spcAft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 Figure 4. Overexpression of Gβγ does not disrupt Gα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β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stin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mplex formation</a:t>
            </a:r>
            <a:endParaRPr lang="en-US" sz="18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buNone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β1 and Gγ2 were over transiently expressed and tested for effect o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ano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mplementation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-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β-arrestin2. (A) Kinetics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β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resti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with Gβ1 and Gγ2 overexpression or a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cDN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ntrol following V2R treatment with AVP (50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(B) AUC quantification of the kinetic curve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s P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&gt;0.05 by two-way ANOVA with Bonferroni post hoc comparing effect of Gβ1 and Gγ2 overexpression versus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cDN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ntrol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s P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&gt;0.05 by two-way ANOVA with Bonferroni post hoc comparing effect of Gβ1 and Gγ2 overexpression versus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cDN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ntrol.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data are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=3 with independent plate replicates. Graphs depict mean values ± SEM and demonstrate net increase of AVP over vehicle treatment.</a:t>
            </a:r>
          </a:p>
          <a:p>
            <a:pPr marL="0" marR="0"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8487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>
              <a:spcAft>
                <a:spcPts val="1200"/>
              </a:spcAft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 Figure 5. Gαi2 and Gαi3 do not complex as efficiently with β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restin</a:t>
            </a:r>
            <a:endParaRPr lang="en-US" sz="18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>
              <a:buNone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ng lower amounts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ubfamily members as assessed by expression plasmid titration does not change the observed result of Gαi2 and Gαi3 associating less efficiently with β-arrestin-2. Cells were transfected with V2R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β-arrestin2, and titratable amounts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Gαi1 (A)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Gαi2 (B)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Gαi3 (C),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Gαo (D). Association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β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resti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mplex formation at titratable amounts of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ubfamily members were assessed wit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ano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luciferase signal upon activation of V2R with AVP (50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Data show n=3 independent plate-based assays per condition and graphs show mean± SEM.</a:t>
            </a:r>
          </a:p>
          <a:p>
            <a:pPr marL="0" marR="0">
              <a:lnSpc>
                <a:spcPct val="115000"/>
              </a:lnSpc>
            </a:pPr>
            <a:b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88585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just">
              <a:spcAft>
                <a:spcPts val="1200"/>
              </a:spcAft>
              <a:buNone/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 Figure 6. The G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1 alpha helical domain is not sufficient to promote G:β-arrestin2 association in HEK293T cells.</a:t>
            </a:r>
            <a:endParaRPr lang="en-US" sz="18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algn="just"/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) schematic of helical domain swaps between Gαi1 and Gαs. B) Gα:β-arrestin2 association in HEK293T cells overexpressing the indicated G protein chimera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g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mBi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β-arrestin2, and V2R upon treatment with AVP (50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C) Area under the curve (AUC) analysis of the kinetics in panel B. **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&lt;0.0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y two-way ANOVA with Bonferroni post hoc test comparing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versus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D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Gαs/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HD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Gαs versus 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D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Gαs/Gα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HD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=3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dependently run plates and graphs depict mean values ± SEM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CE4CE8-6396-4B79-8B31-EF8A199DAAB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331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174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52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356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975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853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988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326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820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047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842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925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59C739-9F19-482D-BDF2-8530657D127B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75DF56-C748-4076-A640-E34647E96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27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96CB9D2-A144-D3B4-8AEA-98A33AB118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8583" y="1301014"/>
            <a:ext cx="9071634" cy="11113971"/>
          </a:xfrm>
          <a:prstGeom prst="rect">
            <a:avLst/>
          </a:prstGeom>
        </p:spPr>
      </p:pic>
      <p:sp>
        <p:nvSpPr>
          <p:cNvPr id="7" name="Title 6">
            <a:extLst>
              <a:ext uri="{FF2B5EF4-FFF2-40B4-BE49-F238E27FC236}">
                <a16:creationId xmlns:a16="http://schemas.microsoft.com/office/drawing/2014/main" id="{82A803D2-FDA7-0E59-498C-C664FE216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576" y="-931860"/>
            <a:ext cx="10515600" cy="2651126"/>
          </a:xfrm>
        </p:spPr>
        <p:txBody>
          <a:bodyPr/>
          <a:lstStyle/>
          <a:p>
            <a:r>
              <a:rPr lang="en-US" dirty="0"/>
              <a:t>Sup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A3A423-9055-0F75-7D9F-436681E7A65C}"/>
              </a:ext>
            </a:extLst>
          </p:cNvPr>
          <p:cNvSpPr txBox="1"/>
          <p:nvPr/>
        </p:nvSpPr>
        <p:spPr>
          <a:xfrm>
            <a:off x="1728393" y="1225321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6A52C9-F129-B2D5-DA87-AF90D11BA026}"/>
              </a:ext>
            </a:extLst>
          </p:cNvPr>
          <p:cNvSpPr txBox="1"/>
          <p:nvPr/>
        </p:nvSpPr>
        <p:spPr>
          <a:xfrm>
            <a:off x="6176682" y="1225321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622C3A-983F-77AF-3F88-088BC4EFB743}"/>
              </a:ext>
            </a:extLst>
          </p:cNvPr>
          <p:cNvSpPr txBox="1"/>
          <p:nvPr/>
        </p:nvSpPr>
        <p:spPr>
          <a:xfrm>
            <a:off x="1647711" y="7315413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450CD8-F170-6DE4-C006-E6A21C5E963C}"/>
              </a:ext>
            </a:extLst>
          </p:cNvPr>
          <p:cNvSpPr txBox="1"/>
          <p:nvPr/>
        </p:nvSpPr>
        <p:spPr>
          <a:xfrm>
            <a:off x="6096000" y="7315413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357822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BD6665-B975-6947-004A-AB5F0C6CF8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43" y="1143987"/>
            <a:ext cx="10494457" cy="7493000"/>
          </a:xfrm>
          <a:prstGeom prst="rect">
            <a:avLst/>
          </a:prstGeom>
        </p:spPr>
      </p:pic>
      <p:sp>
        <p:nvSpPr>
          <p:cNvPr id="3" name="Title 4">
            <a:extLst>
              <a:ext uri="{FF2B5EF4-FFF2-40B4-BE49-F238E27FC236}">
                <a16:creationId xmlns:a16="http://schemas.microsoft.com/office/drawing/2014/main" id="{39016274-1405-7B4E-88C5-DA645EC8C677}"/>
              </a:ext>
            </a:extLst>
          </p:cNvPr>
          <p:cNvSpPr txBox="1">
            <a:spLocks/>
          </p:cNvSpPr>
          <p:nvPr/>
        </p:nvSpPr>
        <p:spPr>
          <a:xfrm>
            <a:off x="0" y="-903285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121917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586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 Figure 2</a:t>
            </a:r>
          </a:p>
        </p:txBody>
      </p:sp>
    </p:spTree>
    <p:extLst>
      <p:ext uri="{BB962C8B-B14F-4D97-AF65-F5344CB8AC3E}">
        <p14:creationId xmlns:p14="http://schemas.microsoft.com/office/powerpoint/2010/main" val="5360837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460284-9F8F-B3F9-8ED5-5E715E6D37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259" y="2500986"/>
            <a:ext cx="11815072" cy="996172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EA8B4829-BCFA-AB24-E246-6B3F09523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865290"/>
            <a:ext cx="10515600" cy="2651126"/>
          </a:xfrm>
        </p:spPr>
        <p:txBody>
          <a:bodyPr/>
          <a:lstStyle/>
          <a:p>
            <a:r>
              <a:rPr lang="en-US" dirty="0"/>
              <a:t>Sup Figure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64D0F0-EEB3-51B0-53D4-C1CD03BE4AE1}"/>
              </a:ext>
            </a:extLst>
          </p:cNvPr>
          <p:cNvSpPr txBox="1"/>
          <p:nvPr/>
        </p:nvSpPr>
        <p:spPr>
          <a:xfrm>
            <a:off x="300318" y="2177821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57E0B9-0D76-F65B-3B21-B92D490A116A}"/>
              </a:ext>
            </a:extLst>
          </p:cNvPr>
          <p:cNvSpPr txBox="1"/>
          <p:nvPr/>
        </p:nvSpPr>
        <p:spPr>
          <a:xfrm>
            <a:off x="300318" y="5001973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3FBE1F-98BE-FDA2-FA27-8EF7DB1CDF31}"/>
              </a:ext>
            </a:extLst>
          </p:cNvPr>
          <p:cNvSpPr txBox="1"/>
          <p:nvPr/>
        </p:nvSpPr>
        <p:spPr>
          <a:xfrm>
            <a:off x="4936866" y="4983638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00C2CA-6004-DD7F-D718-A8FE70A33E12}"/>
              </a:ext>
            </a:extLst>
          </p:cNvPr>
          <p:cNvSpPr txBox="1"/>
          <p:nvPr/>
        </p:nvSpPr>
        <p:spPr>
          <a:xfrm>
            <a:off x="300318" y="8600246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3A2668-A2B3-274C-71B6-12698E5B6D6F}"/>
              </a:ext>
            </a:extLst>
          </p:cNvPr>
          <p:cNvSpPr txBox="1"/>
          <p:nvPr/>
        </p:nvSpPr>
        <p:spPr>
          <a:xfrm>
            <a:off x="5827059" y="8600245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7007685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F203DFDB-9ADF-2C75-4766-FFAABB8AB8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1051" y="3487974"/>
            <a:ext cx="8498625" cy="4574163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C9194DAC-7EDB-4D4F-FEA7-423E707EB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37437" y="-811880"/>
            <a:ext cx="10515600" cy="2651126"/>
          </a:xfrm>
        </p:spPr>
        <p:txBody>
          <a:bodyPr/>
          <a:lstStyle/>
          <a:p>
            <a:r>
              <a:rPr lang="en-US" dirty="0"/>
              <a:t>Sup Figure 4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351A8C7-BD12-18CA-D919-40C2C0605889}"/>
              </a:ext>
            </a:extLst>
          </p:cNvPr>
          <p:cNvCxnSpPr>
            <a:cxnSpLocks/>
          </p:cNvCxnSpPr>
          <p:nvPr/>
        </p:nvCxnSpPr>
        <p:spPr>
          <a:xfrm>
            <a:off x="2419637" y="5511843"/>
            <a:ext cx="0" cy="3262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0B8E5CC-D681-035B-B771-AE4E243605D5}"/>
              </a:ext>
            </a:extLst>
          </p:cNvPr>
          <p:cNvSpPr txBox="1"/>
          <p:nvPr/>
        </p:nvSpPr>
        <p:spPr>
          <a:xfrm>
            <a:off x="2195537" y="5250719"/>
            <a:ext cx="448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V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A35B9E8-066B-90D8-8206-69D12C85D0FD}"/>
              </a:ext>
            </a:extLst>
          </p:cNvPr>
          <p:cNvSpPr txBox="1"/>
          <p:nvPr/>
        </p:nvSpPr>
        <p:spPr>
          <a:xfrm>
            <a:off x="1377557" y="2841644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966905-ED49-3E4F-95B0-BE8D44FF8ABF}"/>
              </a:ext>
            </a:extLst>
          </p:cNvPr>
          <p:cNvSpPr txBox="1"/>
          <p:nvPr/>
        </p:nvSpPr>
        <p:spPr>
          <a:xfrm>
            <a:off x="5121806" y="2841643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899997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4AB02939-5BAB-9567-14A9-0D564EF7B7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3549" y="2803935"/>
            <a:ext cx="9498391" cy="9035055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F7B187B1-26E0-8FCD-2B00-55E77BBD8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33660" y="-893008"/>
            <a:ext cx="10515600" cy="2651126"/>
          </a:xfrm>
        </p:spPr>
        <p:txBody>
          <a:bodyPr/>
          <a:lstStyle/>
          <a:p>
            <a:r>
              <a:rPr lang="en-US" dirty="0"/>
              <a:t>Sup Figure 5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9F52F4B1-3114-A779-56E0-B450BEFD02AF}"/>
              </a:ext>
            </a:extLst>
          </p:cNvPr>
          <p:cNvCxnSpPr>
            <a:cxnSpLocks/>
          </p:cNvCxnSpPr>
          <p:nvPr/>
        </p:nvCxnSpPr>
        <p:spPr>
          <a:xfrm>
            <a:off x="2647950" y="5441485"/>
            <a:ext cx="0" cy="61245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061671FC-5BB1-7A19-FD19-15ED86D228D5}"/>
              </a:ext>
            </a:extLst>
          </p:cNvPr>
          <p:cNvSpPr txBox="1"/>
          <p:nvPr/>
        </p:nvSpPr>
        <p:spPr>
          <a:xfrm>
            <a:off x="2335478" y="5102931"/>
            <a:ext cx="5360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VP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63999CC-7EF4-AD61-D054-EAB258866A86}"/>
              </a:ext>
            </a:extLst>
          </p:cNvPr>
          <p:cNvCxnSpPr>
            <a:cxnSpLocks/>
          </p:cNvCxnSpPr>
          <p:nvPr/>
        </p:nvCxnSpPr>
        <p:spPr>
          <a:xfrm>
            <a:off x="7215601" y="5441485"/>
            <a:ext cx="0" cy="61245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E2D1F00-CA93-149B-DA71-19FB7C317A71}"/>
              </a:ext>
            </a:extLst>
          </p:cNvPr>
          <p:cNvSpPr txBox="1"/>
          <p:nvPr/>
        </p:nvSpPr>
        <p:spPr>
          <a:xfrm>
            <a:off x="6903129" y="5102931"/>
            <a:ext cx="5360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VP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A23D350-7D82-8F84-E077-BEA6A87063E3}"/>
              </a:ext>
            </a:extLst>
          </p:cNvPr>
          <p:cNvCxnSpPr>
            <a:cxnSpLocks/>
          </p:cNvCxnSpPr>
          <p:nvPr/>
        </p:nvCxnSpPr>
        <p:spPr>
          <a:xfrm>
            <a:off x="2692400" y="10256680"/>
            <a:ext cx="0" cy="41371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978CC9F-9422-29F9-E43F-F91712C6B620}"/>
              </a:ext>
            </a:extLst>
          </p:cNvPr>
          <p:cNvSpPr txBox="1"/>
          <p:nvPr/>
        </p:nvSpPr>
        <p:spPr>
          <a:xfrm>
            <a:off x="2424378" y="9932323"/>
            <a:ext cx="5360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VP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E641995-6002-9A6C-5668-65B3D645226A}"/>
              </a:ext>
            </a:extLst>
          </p:cNvPr>
          <p:cNvCxnSpPr>
            <a:cxnSpLocks/>
          </p:cNvCxnSpPr>
          <p:nvPr/>
        </p:nvCxnSpPr>
        <p:spPr>
          <a:xfrm>
            <a:off x="7215601" y="9845458"/>
            <a:ext cx="0" cy="41122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F3928AE-959F-FCF8-65A0-B780D3F85655}"/>
              </a:ext>
            </a:extLst>
          </p:cNvPr>
          <p:cNvSpPr txBox="1"/>
          <p:nvPr/>
        </p:nvSpPr>
        <p:spPr>
          <a:xfrm>
            <a:off x="6947579" y="9493561"/>
            <a:ext cx="5360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VP</a:t>
            </a:r>
          </a:p>
        </p:txBody>
      </p:sp>
    </p:spTree>
    <p:extLst>
      <p:ext uri="{BB962C8B-B14F-4D97-AF65-F5344CB8AC3E}">
        <p14:creationId xmlns:p14="http://schemas.microsoft.com/office/powerpoint/2010/main" val="1032844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3D52A1B-C961-7C58-7DB3-493338DD42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4416" y="3621483"/>
            <a:ext cx="7620660" cy="7675529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E3C2429E-B016-EF8B-699C-504188A67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805920"/>
            <a:ext cx="10515600" cy="2651126"/>
          </a:xfrm>
        </p:spPr>
        <p:txBody>
          <a:bodyPr/>
          <a:lstStyle/>
          <a:p>
            <a:r>
              <a:rPr lang="en-US" dirty="0"/>
              <a:t>Sup Figure 6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B0B247F4-B9B2-A4A8-F9AC-30FCF035A838}"/>
              </a:ext>
            </a:extLst>
          </p:cNvPr>
          <p:cNvCxnSpPr>
            <a:cxnSpLocks/>
          </p:cNvCxnSpPr>
          <p:nvPr/>
        </p:nvCxnSpPr>
        <p:spPr>
          <a:xfrm>
            <a:off x="3684766" y="9194495"/>
            <a:ext cx="0" cy="3262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A9352D75-97F7-1636-2547-C0C85A2E7879}"/>
              </a:ext>
            </a:extLst>
          </p:cNvPr>
          <p:cNvSpPr txBox="1"/>
          <p:nvPr/>
        </p:nvSpPr>
        <p:spPr>
          <a:xfrm>
            <a:off x="3460666" y="8933371"/>
            <a:ext cx="448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V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2B2789-5D78-E6B8-6421-746587F8F311}"/>
              </a:ext>
            </a:extLst>
          </p:cNvPr>
          <p:cNvSpPr txBox="1"/>
          <p:nvPr/>
        </p:nvSpPr>
        <p:spPr>
          <a:xfrm>
            <a:off x="1753682" y="2975152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C49A55-2BC2-664A-94E6-81683AB43875}"/>
              </a:ext>
            </a:extLst>
          </p:cNvPr>
          <p:cNvSpPr txBox="1"/>
          <p:nvPr/>
        </p:nvSpPr>
        <p:spPr>
          <a:xfrm>
            <a:off x="1778035" y="6812917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7DA2C8-92CF-E665-3024-3828807F9661}"/>
              </a:ext>
            </a:extLst>
          </p:cNvPr>
          <p:cNvSpPr txBox="1"/>
          <p:nvPr/>
        </p:nvSpPr>
        <p:spPr>
          <a:xfrm>
            <a:off x="5827059" y="6812917"/>
            <a:ext cx="537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99703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BCC0EA4803F6A41BB1714C5DC475165" ma:contentTypeVersion="15" ma:contentTypeDescription="Create a new document." ma:contentTypeScope="" ma:versionID="a4394d6c69a48355f344294ccd415713">
  <xsd:schema xmlns:xsd="http://www.w3.org/2001/XMLSchema" xmlns:xs="http://www.w3.org/2001/XMLSchema" xmlns:p="http://schemas.microsoft.com/office/2006/metadata/properties" xmlns:ns3="e4c054e6-6b6d-4f91-bf75-cf7bbaaf68d6" xmlns:ns4="34ee3a45-d572-489e-8d65-4ec7de0d5d21" targetNamespace="http://schemas.microsoft.com/office/2006/metadata/properties" ma:root="true" ma:fieldsID="c319b2ebaa5186a3a3b6c77f0b0e6c12" ns3:_="" ns4:_="">
    <xsd:import namespace="e4c054e6-6b6d-4f91-bf75-cf7bbaaf68d6"/>
    <xsd:import namespace="34ee3a45-d572-489e-8d65-4ec7de0d5d2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c054e6-6b6d-4f91-bf75-cf7bbaaf68d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4ee3a45-d572-489e-8d65-4ec7de0d5d21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e4c054e6-6b6d-4f91-bf75-cf7bbaaf68d6" xsi:nil="true"/>
  </documentManagement>
</p:properties>
</file>

<file path=customXml/itemProps1.xml><?xml version="1.0" encoding="utf-8"?>
<ds:datastoreItem xmlns:ds="http://schemas.openxmlformats.org/officeDocument/2006/customXml" ds:itemID="{577406A1-AB23-469F-903A-03575C3DE53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4c054e6-6b6d-4f91-bf75-cf7bbaaf68d6"/>
    <ds:schemaRef ds:uri="34ee3a45-d572-489e-8d65-4ec7de0d5d2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7E9AA8B-E764-4A4A-BCC0-AC7921A85FF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41EA45A-F55F-43F4-BEC1-4161E9D19589}">
  <ds:schemaRefs>
    <ds:schemaRef ds:uri="http://purl.org/dc/dcmitype/"/>
    <ds:schemaRef ds:uri="http://purl.org/dc/terms/"/>
    <ds:schemaRef ds:uri="http://purl.org/dc/elements/1.1/"/>
    <ds:schemaRef ds:uri="http://schemas.microsoft.com/office/infopath/2007/PartnerControls"/>
    <ds:schemaRef ds:uri="e4c054e6-6b6d-4f91-bf75-cf7bbaaf68d6"/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34ee3a45-d572-489e-8d65-4ec7de0d5d21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61</TotalTime>
  <Words>906</Words>
  <Application>Microsoft Office PowerPoint</Application>
  <PresentationFormat>Custom</PresentationFormat>
  <Paragraphs>47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ptos</vt:lpstr>
      <vt:lpstr>Aptos Display</vt:lpstr>
      <vt:lpstr>Arial</vt:lpstr>
      <vt:lpstr>Calibri</vt:lpstr>
      <vt:lpstr>Palatino Linotype</vt:lpstr>
      <vt:lpstr>Times New Roman</vt:lpstr>
      <vt:lpstr>Office Theme</vt:lpstr>
      <vt:lpstr>Sup Figure 1</vt:lpstr>
      <vt:lpstr>PowerPoint Presentation</vt:lpstr>
      <vt:lpstr>Sup Figure 3</vt:lpstr>
      <vt:lpstr>Sup Figure 4</vt:lpstr>
      <vt:lpstr>Sup Figure 5</vt:lpstr>
      <vt:lpstr>Sup Figure 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laudia Lee</dc:creator>
  <cp:lastModifiedBy>Claudia Lee</cp:lastModifiedBy>
  <cp:revision>44</cp:revision>
  <dcterms:created xsi:type="dcterms:W3CDTF">2024-11-21T16:13:13Z</dcterms:created>
  <dcterms:modified xsi:type="dcterms:W3CDTF">2025-06-24T20:38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BCC0EA4803F6A41BB1714C5DC475165</vt:lpwstr>
  </property>
</Properties>
</file>